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handoutMasterIdLst>
    <p:handoutMasterId r:id="rId13"/>
  </p:handoutMasterIdLst>
  <p:sldIdLst>
    <p:sldId id="269" r:id="rId2"/>
    <p:sldId id="296" r:id="rId3"/>
    <p:sldId id="276" r:id="rId4"/>
    <p:sldId id="277" r:id="rId5"/>
    <p:sldId id="270" r:id="rId6"/>
    <p:sldId id="271" r:id="rId7"/>
    <p:sldId id="272" r:id="rId8"/>
    <p:sldId id="273" r:id="rId9"/>
    <p:sldId id="297" r:id="rId10"/>
    <p:sldId id="289" r:id="rId11"/>
  </p:sldIdLst>
  <p:sldSz cx="6858000" cy="9144000" type="screen4x3"/>
  <p:notesSz cx="67833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8">
          <p15:clr>
            <a:srgbClr val="A4A3A4"/>
          </p15:clr>
        </p15:guide>
        <p15:guide id="2" pos="403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ohn Nolan" initials="JN" lastIdx="3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88" autoAdjust="0"/>
    <p:restoredTop sz="93305" autoAdjust="0"/>
  </p:normalViewPr>
  <p:slideViewPr>
    <p:cSldViewPr>
      <p:cViewPr>
        <p:scale>
          <a:sx n="60" d="100"/>
          <a:sy n="60" d="100"/>
        </p:scale>
        <p:origin x="1976" y="28"/>
      </p:cViewPr>
      <p:guideLst>
        <p:guide orient="horz" pos="528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1750" y="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062BD3-2110-49DC-99B1-1E58C9EE8A10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1750" y="942975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841E9-52F1-430A-89F6-07AA96990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99764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1750" y="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70E258-B261-4340-8F43-EBA0D72AB503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5188" y="1241425"/>
            <a:ext cx="251301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7863" y="4776788"/>
            <a:ext cx="5427662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1750" y="9429750"/>
            <a:ext cx="29400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491847-2071-4585-ADA3-893866BBED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3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6170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349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8172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dirty="0"/>
              <a:t>Green-high expression = poor prognosis</a:t>
            </a:r>
          </a:p>
          <a:p>
            <a:r>
              <a:rPr lang="en-IE" dirty="0"/>
              <a:t>Red-low</a:t>
            </a:r>
            <a:r>
              <a:rPr lang="en-IE" baseline="0" dirty="0"/>
              <a:t> expression= poor prognosi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028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773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27211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9491847-2071-4585-ADA3-893866BBED7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315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12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013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56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819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399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324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941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104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816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26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071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6FE00-8F94-424D-9940-60BFDB061AC4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4FF38-9559-4A43-AFA6-3E9AA9CBC3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323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johnnolan\Desktop\124-paper\Raw figures\124-split in1-2-3 vs-4vs4s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" y="540327"/>
            <a:ext cx="3348228" cy="2514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johnnolan\Desktop\124-paper\Raw figures\124 split in st4 mna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964" y="609599"/>
            <a:ext cx="3531036" cy="24324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533400"/>
            <a:ext cx="374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35726" y="533400"/>
            <a:ext cx="374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15240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dirty="0"/>
              <a:t>Supplementary-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61702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68580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sz="1800" dirty="0"/>
              <a:t>Supplementary-S7</a:t>
            </a:r>
            <a:endParaRPr lang="en-US" sz="1800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3258" y="533400"/>
            <a:ext cx="4231483" cy="390650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852" y="4648200"/>
            <a:ext cx="6334293" cy="34994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4508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52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15"/>
          <a:stretch>
            <a:fillRect/>
          </a:stretch>
        </p:blipFill>
        <p:spPr bwMode="auto">
          <a:xfrm>
            <a:off x="228600" y="616527"/>
            <a:ext cx="5676900" cy="26336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kumimoji="0" lang="en-US" altLang="en-US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1 Association of miR-124-3p expression with neuroblastoma disease outcome.</a:t>
            </a: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8"/>
          <p:cNvSpPr>
            <a:spLocks noChangeArrowheads="1"/>
          </p:cNvSpPr>
          <p:nvPr/>
        </p:nvSpPr>
        <p:spPr bwMode="auto">
          <a:xfrm>
            <a:off x="228600" y="3434770"/>
            <a:ext cx="5676900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Abbreviations: p = p-value for event-free survival; HR=hazard ratio; INSS = international neuroblastoma staging system; 95% CI = 95% confidence interval. (a) Univariate Cox proportional hazard regression analyses of event-free survival in 329 neuroblastoma patients in total. (b) Multivariate Cox proportional hazard regression analysis of event-free survival in 100 neuroblastoma patients (other patients were removed from the analysis due to missing data). Variables included: MYCN amplification (yes, no), 11q deletion (yes, no) and stage (1,2,3,4, 4S). (c) Stage stratified Cox proportional hazard regression analysis of event-free survival in 290 neuroblastoma patients. Variables included: MYCN amplification (yes, no) and stage (Stages1,2,3,4S as stratum 1 and Stage 4 as stratum 2)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15240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dirty="0"/>
              <a:t>Supplementary-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67068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85800" y="304800"/>
            <a:ext cx="5334000" cy="88008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dirty="0">
                <a:effectLst/>
                <a:ea typeface="Calibri"/>
                <a:cs typeface="Calibri,Bold"/>
              </a:rPr>
              <a:t>Supplementary- S3 </a:t>
            </a:r>
          </a:p>
          <a:p>
            <a:pPr algn="just">
              <a:lnSpc>
                <a:spcPct val="115000"/>
              </a:lnSpc>
            </a:pPr>
            <a:endParaRPr lang="en-US" dirty="0">
              <a:effectLst/>
              <a:ea typeface="Calibri"/>
              <a:cs typeface="Calibri,Bold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MYH9 3’UTR-miR-124-3p: NM_002473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UUUAGAAGAGAGUAGCUCGUCCUCACUGGUCUACACUGGUUGCCGAAUUUACUUGUA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CCUAACUGUUUUGUAUAUGCUGCAUUGAGACUUACGGCAAGAAGGCAUUUUUUUUUUUUA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AAACAAACUCUCAAAUCAUGAAGUGAUAUAAAAGCUGCAUAUGCCUACAAAGCUCUGAAUU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UCCCAGUUGCUGUCACAAAGGAGUGAGUGAAACUCCCACCCUACCCCCUUUUUUAUAUAAU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A</a:t>
            </a:r>
            <a:r>
              <a:rPr lang="en-US" sz="1000" b="1" u="sng" dirty="0">
                <a:highlight>
                  <a:srgbClr val="FFFF00"/>
                </a:highlight>
                <a:ea typeface="Calibri"/>
                <a:cs typeface="Calibri"/>
              </a:rPr>
              <a:t>GUGCCUUA</a:t>
            </a:r>
            <a:r>
              <a:rPr lang="en-US" sz="1000" dirty="0">
                <a:ea typeface="Calibri"/>
                <a:cs typeface="Calibri"/>
              </a:rPr>
              <a:t>GCAUGUGUUGCAGCUGUCACCACUACAGUAAGCUGGUUUACAGAUGUUUUCCA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GAGCAUCACAAUAAAGAGAACCAUGUGCUACG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Wild-type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TTTAGAAGAGAGTAGCTCGTCCTCACTGGTCTACACTGGTTGCCGAATTTACTTGTATTCCT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GTTTTGTATATGCTGCATTGAGACTTACGGCAAGAAGGCATTTTTTTTTTTTAAAGGAAACAAACTC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AATCATGAAGTGATATAAAAGCTGCATATGCCTACAAAGCTCTGAATTCAGGTCCCAGTTGCTGT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AAGGAGTGAGTGAAACTCCCACCCTACCCCCTTTTTTATATAATAAAA</a:t>
            </a:r>
            <a:r>
              <a:rPr lang="en-US" sz="1000" b="1" u="sng" dirty="0">
                <a:highlight>
                  <a:srgbClr val="FFFF00"/>
                </a:highlight>
                <a:ea typeface="Calibri"/>
                <a:cs typeface="Calibri"/>
              </a:rPr>
              <a:t>GTGCCTTA</a:t>
            </a:r>
            <a:r>
              <a:rPr lang="en-US" sz="1000" dirty="0">
                <a:ea typeface="Calibri"/>
                <a:cs typeface="Calibri"/>
              </a:rPr>
              <a:t>GCATGTGTTG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TGTCACCACTACAGTAAGCTGGTTTACAGATGTTTTCCACTGAGCATCACAATAAAGAGAACCATG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TACGA GCGGCC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Mutated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TTTAGAAGAGAGTAGCTCGTCCTCACTGGTCTACACTGGTTGCCGAATTTACTTGTATTCCT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GTTTTGTATATGCTGCATTGAGACTTACGGCAAGAAGGCATTTTTTTTTTTTAAAGGAAACAAACTC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AATCATGAAGTGATATAAAAGCTGCATATGCCTACAAAGCTCTGAATTCAGGTCCCAGTTGCTGT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AAGGAGTGAGTGAAACTCCCACCCTACCCCCTTTTTTATATAATAAAAGCATGTGTTGCAGCTGTCA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CTACAGTAAGCTGGTTTACAGATGTTTTCCACTGAGCATCACAATAAAGAGAACCATGTGCTACG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GGCC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ACTN4 3’UTR-miR-124-3p:NM_004924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UUGGGGAGACUUGGGGCCAGCGCUUCUGGUCUGGUAAAUAUGUAUGAUGUGUUGUGCUUU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UAACCAAGGAGGGGCCAGUGGAUUCCCACAGCACAACCGGUCCCUUCCAUGCCCUGGGAUGCC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CCACACCCAGGUCUCUUCCUUUGCUCUGAGGUCCCUUCAAGGCCUCCCCAAUCCAGGCCAAA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CCAU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UGCCUU</a:t>
            </a:r>
            <a:r>
              <a:rPr lang="en-US" sz="1000" dirty="0">
                <a:ea typeface="Calibri"/>
                <a:cs typeface="Calibri"/>
              </a:rPr>
              <a:t>GUCCAGGAACUGCCUGGGCCAUGCGAGGGGCCAGCAGAGGGCGCCACCACCA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UGACGGCUGGGGACCCACCCAGCCCCUCUCCCCUCUCUGCUCCAGACUCACUUGCCAUUGCCAG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GAUGGCCCCAACAAGCACCCCGCUUUUGCAGCAGAGGAGCUGAGUUGGCAGACCGGGCCCCCC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AACCGCACCCCAUCC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Wild-type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GTTGGGGAGACTTGGGGCCAGCGCTTCTGGTCTGGTAAATATGTATGATGTGTTGTGCTTTT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AACCAAGGAGGGGCCAGTGGATTCCCACAGCACAACCGGTCCCTTCCATGCCCTGGGATGCCTCA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CACCCAGGTCTCTTCCTTTGCTCTGAGGTCCCTTCAAGGCCTCCCCAATCCAGGCCAAAGCCCCAT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T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CCTT</a:t>
            </a:r>
            <a:r>
              <a:rPr lang="en-US" sz="1000" dirty="0">
                <a:ea typeface="Calibri"/>
                <a:cs typeface="Calibri"/>
              </a:rPr>
              <a:t>GTCCAGGAACTGCCTGGGCCATGCGAGGGGCCAGCAGAGGGCGCCACCACCACCTGACGGCT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GACCCACCCAGCCCCTCTCCCCTCTCTGCTCCAGACTCACTTGCCATTGCCAGGAGATGGCCCCAA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GCACCCCGCTTTTGCAGCAGAGGAGCTGAGTTGGCAGACCGGGCCCCCCTGAACCGCACCCCATC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GCGGCC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Mutated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GTTGGGGAGACTTGGGGCCAGCGCTTCTGGTCTGGTAAATATGTATGATGTGTTGTGCTTTT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AACCAAGGAGGGGCCAGTGGATTCCCACAGCACAACCGGTCCCTTCCATGCCCTGGGATGCCTCA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CACCCAGGTCTCTTCCTTTGCTCTGAGGTCCCTTCAAGGCCTCCCCAATCCAGGCCAAAGCCCCATGT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AGGAACTGCCTGGGCCATGCGAGGGGCCAGCAGAGGGCGCCACCACCACCTGACGGCTGGGGACCC</a:t>
            </a:r>
            <a:endParaRPr lang="en-US" sz="1000" dirty="0">
              <a:ea typeface="Calibri"/>
              <a:cs typeface="Times New Roman"/>
            </a:endParaRPr>
          </a:p>
          <a:p>
            <a:r>
              <a:rPr lang="en-US" sz="1000" dirty="0">
                <a:ea typeface="Calibri"/>
                <a:cs typeface="Calibri"/>
              </a:rPr>
              <a:t>ACCCAGCCCCTCTCCCCTCTCTGCTCCAGACTCACTTGCCATTGCCAGGAGATGGCCCCAACAAGCACCC</a:t>
            </a:r>
          </a:p>
          <a:p>
            <a:r>
              <a:rPr lang="en-US" sz="1000" dirty="0"/>
              <a:t>CGCTTTTGCAGCAGAGGAGCTGAGTTGGCAGACCGGGCCCCCCTGAACCGCACCCCATCCCAGCGGCC</a:t>
            </a:r>
          </a:p>
          <a:p>
            <a:r>
              <a:rPr lang="en-US" sz="1000" dirty="0"/>
              <a:t>GC</a:t>
            </a:r>
          </a:p>
          <a:p>
            <a:pPr algn="just">
              <a:lnSpc>
                <a:spcPct val="115000"/>
              </a:lnSpc>
            </a:pPr>
            <a:endParaRPr lang="en-US" sz="10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932211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75568" y="609600"/>
            <a:ext cx="5268032" cy="38087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PLEC 3’UTR-miR-124-3p - 1: NM_000445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UUCCUCCCAAGUGGUGCCUAAAGUUUAACCAAAAAGACCAGACUAAUAUAUUAAUAUAUAUCU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UGUCCAGACAGCCUGUAUCUUGGGGGACAGGGCUGGCCCAGCCCUGCUGGCCGCCUCACCCCC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GGGUCUCCUCACUCCCUUCUACCUGCCACUCACACAGCCAG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UGCCUU</a:t>
            </a:r>
            <a:r>
              <a:rPr lang="en-US" sz="1000" dirty="0">
                <a:ea typeface="Calibri"/>
                <a:cs typeface="Calibri"/>
              </a:rPr>
              <a:t>GGAGGGUCCCAAGCU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CCCCAGCCCACCCUCCUGUCUUCCCAGGGUAGCCCGCCUGCCAGUCCUAGCUGCACAGGGCA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GGGCCCAACCCUGUCUGUAGAGGGCCCUGGUGUUUCUAGCACUGGCCUGCACGGUGGGCCUU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UGGGGACGGGGGGCCCCAGUCAGCCUCUCUCCCAGUCUACCCAGAGAAGCC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Wild-type 1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CTTCCTCCCAAGTGGTGCCTAAAGTTTAACCAAAAAGACCAGACTAATATATTAATATATATC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TGTCCAGACAGCCTGTATCTTGGGGGACAGGGCTGGCCCAGCCCTGCTGGCCGCCTCACCCCCTC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TCTCCTCACTCCCTTCTACCTGCCACTCACACAGCCAG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TGCCTT</a:t>
            </a:r>
            <a:r>
              <a:rPr lang="en-US" sz="1000" dirty="0">
                <a:ea typeface="Calibri"/>
                <a:cs typeface="Calibri"/>
              </a:rPr>
              <a:t>GGAGGGTCCCAAGCTGGGCC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GCCCACCCTCCTGTCTTCCCAGGGTAGCCCGCCTGCCAGTCCTAGCTGCACAGGGCAGCTGGGCCC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CCTGTCTGTAGAGGGCCCTGGTGTTTCTAGCACTGGCCTGCACGGTGGGCCTTGCTGGGGACGGGG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CCCAGTCAGCCTCTCTCCCAGTCTACCCAGAGAAGCGGCC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Mutated 1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CTTCCTCCCAAGTGGTGCCTAAAGTTTAACCAAAAAGACCAGACTAATATATTAATATATATC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TGTCCAGACAGCCTGTATCTTGGGGGACAGGGCTGGCCCAGCCCTGCTGGCCGCCTCACCCCCTC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GTCTCCTCACTCCCTTCTACCTGCCACTCACACAGCCAGGGAGGGTCCCAAGCTGGGCCCCAGCCCA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CTCCTGTCTTCCCAGGGTAGCCCGCCTGCCAGTCCTAGCTGCACAGGGCAGCTGGGCCCAACCCTGT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GTAGAGGGCCCTGGTGTTTCTAGCACTGGCCTGCACGGTGGGCCTTGCTGGGGACGGGGGGCCC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TCAGCCTCTCTCCCAGTCTACCCAGAGAAGCGGCCGC</a:t>
            </a:r>
            <a:endParaRPr lang="en-US" sz="1000" dirty="0">
              <a:ea typeface="Calibri"/>
              <a:cs typeface="Times New Roman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85800" y="4447922"/>
            <a:ext cx="5334000" cy="41626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PLEC 3’UTR-miR-124-3p - 2: NM_000445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GCACGGUGGGCCUUGCUGGGGACGGGGGGCCCCAGUCAGCCUCUCUCCCAGUCUACCCAGAGA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CCCUUCCCCAUGGGAAGACGAGGCCCUCGGGCCCAGCCCCCACAGUGCUGUCUGAUCUGUGC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UCCAGCUCACCCCCCACACUCACUCCUGAGACCCCUGGCCUCCGGCGUCAGCCUCCAGCCUCUGU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UCCCCUAGUAA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UGCCUU</a:t>
            </a:r>
            <a:r>
              <a:rPr lang="en-US" sz="1000" dirty="0">
                <a:ea typeface="Calibri"/>
                <a:cs typeface="Calibri"/>
              </a:rPr>
              <a:t>CCAUGUCGGCCUCUAACCCCAGGCCCCGAGGACCCAGACCCAGUGGG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AGGCGGACGUUCCAGCCGGCAUGGCUGGGAACUGCAGACCUGUCCUCCUGGUGGGUCCAGGG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CCUCCAGCUUGUGGAGCCCCACACUGGGGUGCCGCCUGCCCGUCUCUCUCCCAUGGAGCCCCA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CCCUUUGGGCCCA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Wild-type 2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TGCACGGTGGGCCTTGCTGGGGACGGGGGGCCCCAGTCAGCCTCTCTCCCAGTCTACCCAG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AAGCCCCTTCCCCATGGGAAGACGAGGCCCTCGGGCCCAGCCCCCACAGTGCTGTCTGATCTGTGCT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CCAGCTCACCCCCCACACTCACTCCTGAGACCCCTGGCCTCCGGCGTCAGCCTCCAGCCTCTGTTCC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AGTAA</a:t>
            </a:r>
            <a:r>
              <a:rPr lang="en-US" sz="1000" b="1" u="sng" dirty="0">
                <a:highlight>
                  <a:srgbClr val="FFFF00"/>
                </a:highlight>
                <a:ea typeface="Calibri,Bold"/>
                <a:cs typeface="Calibri,Bold"/>
              </a:rPr>
              <a:t>GTGCCTT</a:t>
            </a:r>
            <a:r>
              <a:rPr lang="en-US" sz="1000" dirty="0">
                <a:ea typeface="Calibri"/>
                <a:cs typeface="Calibri"/>
              </a:rPr>
              <a:t>CCATGTCGGCCTCTAACCCCAGGCCCCGAGGACCCAGACCCAGTGGGGAGGCGG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GTTCCAGCCGGCATGGCTGGGAACTGCAGACCTGTCCTCCTGGTGGGTCCAGGGGCCCCTCCAGCT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TGGAGCCCCACACTGGGGTGCCGCCTGCCCGTCTCTCTCCCATGGAGCCCCAGCCCCCTTTGCGGCCG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b="1" dirty="0">
                <a:effectLst/>
                <a:ea typeface="Calibri"/>
                <a:cs typeface="Calibri,Bold"/>
              </a:rPr>
              <a:t>Mutated 2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CTCGAGTGCACGGTGGGCCTTGCTGGGGACGGGGGGCCCCAGTCAGCCTCTCTCCCAGTCTACCCAG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AAGCCCCTTCCCCATGGGAAGACGAGGCCCTCGGGCCCAGCCCCCACAGTGCTGTCTGATCTGTGCTT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CCAGCTCACCCCCCACACTCACTCCTGAGACCCCTGGCCTCCGGCGTCAGCCTCCAGCCTCTGTTCCC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TAGTAACCATGTCGGCCTCTAACCCCAGGCCCCGAGGACCCAGACCCAGTGGGGAGGCGGACGTTCCA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</a:pPr>
            <a:r>
              <a:rPr lang="en-US" sz="1000" dirty="0">
                <a:ea typeface="Calibri"/>
                <a:cs typeface="Calibri"/>
              </a:rPr>
              <a:t>GCCGGCATGGCTGGGAACTGCAGACCTGTCCTCCTGGTGGGTCCAGGGGCCCCTCCAGCTTGTGGAGC</a:t>
            </a:r>
            <a:endParaRPr lang="en-US" sz="1000" dirty="0"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000" dirty="0">
                <a:ea typeface="Calibri"/>
                <a:cs typeface="Calibri"/>
              </a:rPr>
              <a:t>CCCACACTGGGGTGCCGCCTGCCCGTCTCTCTCCCATGGAGCCCCAGCCCCCTTTGCGGCCGC</a:t>
            </a:r>
            <a:endParaRPr lang="en-US" sz="10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722379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4823"/>
            <a:ext cx="6858000" cy="243416"/>
          </a:xfrm>
        </p:spPr>
        <p:txBody>
          <a:bodyPr>
            <a:noAutofit/>
          </a:bodyPr>
          <a:lstStyle/>
          <a:p>
            <a:r>
              <a:rPr lang="en-IE" sz="1800" dirty="0"/>
              <a:t>Supplementary- S4</a:t>
            </a:r>
            <a:endParaRPr lang="en-US" sz="18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3559036"/>
              </p:ext>
            </p:extLst>
          </p:nvPr>
        </p:nvGraphicFramePr>
        <p:xfrm>
          <a:off x="1066800" y="762000"/>
          <a:ext cx="4495800" cy="6519636"/>
        </p:xfrm>
        <a:graphic>
          <a:graphicData uri="http://schemas.openxmlformats.org/drawingml/2006/table">
            <a:tbl>
              <a:tblPr/>
              <a:tblGrid>
                <a:gridCol w="1038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71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367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135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#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ugo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bese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-value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C16A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2850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60E-1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MTA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1845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0E-1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HRF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1769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0E-1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KT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6247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E-0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1714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0E-0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GPL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5086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E-0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GS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6438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E-0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FNB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8017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0E-0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5878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0E-0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74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YD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490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E-0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IB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7316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0E-0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G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9750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70E-0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VER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4018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E-0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XN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7383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0E-0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SSCA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3532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QGAP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0811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F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4057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X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3359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A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7778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4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HR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9123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NRNPA2B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4242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4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R3C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7931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PT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3584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2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MOTL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4522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0E-0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XA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0083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CK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4047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OX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7463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5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4HA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9415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T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5784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CE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9325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9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LF6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7436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7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DNF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6723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842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ZH2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78348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1</a:t>
                      </a:r>
                    </a:p>
                  </a:txBody>
                  <a:tcPr marL="8874" marR="8874" marT="887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53210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959" y="226548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399" y="2508284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959" y="479002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398" y="479002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354" y="7071756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AutoShape 9" descr="https://hgserver1.amc.nl/r2/graph/kaplanscan_nbnrctfgitf283_UHRF1_3817698-15312702406214.png"/>
          <p:cNvSpPr>
            <a:spLocks noChangeAspect="1" noChangeArrowheads="1"/>
          </p:cNvSpPr>
          <p:nvPr/>
        </p:nvSpPr>
        <p:spPr bwMode="auto">
          <a:xfrm>
            <a:off x="155575" y="-21631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AutoShape 11" descr="https://hgserver1.amc.nl/r2/graph/kaplanscan_nbnrctfgitf283_UHRF1_3817698-15312702406214.png"/>
          <p:cNvSpPr>
            <a:spLocks noChangeAspect="1" noChangeArrowheads="1"/>
          </p:cNvSpPr>
          <p:nvPr/>
        </p:nvSpPr>
        <p:spPr bwMode="auto">
          <a:xfrm>
            <a:off x="307975" y="130769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AutoShape 13" descr="https://hgserver1.amc.nl/r2/graph/kaplanscan_nbnrctfgitf283_UHRF1_3817698-15312702406214.png"/>
          <p:cNvSpPr>
            <a:spLocks noChangeAspect="1" noChangeArrowheads="1"/>
          </p:cNvSpPr>
          <p:nvPr/>
        </p:nvSpPr>
        <p:spPr bwMode="auto">
          <a:xfrm>
            <a:off x="460375" y="283169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399" y="28317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958" y="2508283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399" y="7071756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7999" cy="244489"/>
          </a:xfrm>
        </p:spPr>
        <p:txBody>
          <a:bodyPr>
            <a:noAutofit/>
          </a:bodyPr>
          <a:lstStyle/>
          <a:p>
            <a:r>
              <a:rPr lang="en-IE" sz="1800" dirty="0">
                <a:latin typeface="+mn-lt"/>
              </a:rPr>
              <a:t>Supplementary-</a:t>
            </a:r>
            <a:r>
              <a:rPr lang="en-IE" sz="1800" b="1" dirty="0">
                <a:latin typeface="+mn-lt"/>
              </a:rPr>
              <a:t> </a:t>
            </a:r>
            <a:r>
              <a:rPr lang="en-IE" sz="1800" dirty="0">
                <a:latin typeface="+mn-lt"/>
              </a:rPr>
              <a:t>S5</a:t>
            </a:r>
            <a:endParaRPr 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2381812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5240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2497695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3805" y="472440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6798705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3804" y="6846206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5240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99" y="2497695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4724399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402984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28600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99" y="2497695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4778829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600" y="4778829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98" y="7069695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599" y="228599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598" y="2497694"/>
            <a:ext cx="2713905" cy="2074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532951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200" y="3462844"/>
            <a:ext cx="3392812" cy="128027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8714" y="796200"/>
            <a:ext cx="3345488" cy="215619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485971" y="535903"/>
            <a:ext cx="33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1200" dirty="0"/>
              <a:t>Oncogene Targets (23)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619975" y="3184726"/>
            <a:ext cx="33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1200" dirty="0"/>
              <a:t>Tumour Suppressor Gene Targets (10)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26000" y="454078"/>
            <a:ext cx="3336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1200" dirty="0"/>
              <a:t>Validated miR-124-3p Targets (90)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71307" y="464598"/>
            <a:ext cx="374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656162" y="3102864"/>
            <a:ext cx="374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164120" y="4723882"/>
            <a:ext cx="1571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-Log10 (Binomial </a:t>
            </a:r>
            <a:r>
              <a:rPr lang="en-IE" sz="8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</a:t>
            </a:r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value)</a:t>
            </a:r>
            <a:endParaRPr lang="en-US" sz="8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064385" y="2814920"/>
            <a:ext cx="1676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-Log10 (Binomial </a:t>
            </a:r>
            <a:r>
              <a:rPr lang="en-IE" sz="8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</a:t>
            </a:r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value)</a:t>
            </a:r>
            <a:endParaRPr lang="en-US" sz="8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476" y="728518"/>
            <a:ext cx="3345488" cy="217868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770147" y="2799680"/>
            <a:ext cx="1676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-Log10 (Binomial </a:t>
            </a:r>
            <a:r>
              <a:rPr lang="en-IE" sz="8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</a:t>
            </a:r>
            <a:r>
              <a:rPr lang="en-IE" sz="8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value)</a:t>
            </a:r>
            <a:endParaRPr lang="en-US" sz="8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87001" y="4806315"/>
            <a:ext cx="6629400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dirty="0">
              <a:latin typeface="Palatino Linotype" panose="02040502050505030304" pitchFamily="18" charset="0"/>
            </a:endParaRPr>
          </a:p>
          <a:p>
            <a:pPr algn="just"/>
            <a:r>
              <a:rPr lang="en-US" sz="1000" dirty="0">
                <a:latin typeface="Palatino Linotype" panose="02040502050505030304" pitchFamily="18" charset="0"/>
              </a:rPr>
              <a:t>(</a:t>
            </a:r>
            <a:r>
              <a:rPr lang="en-US" sz="1000" dirty="0" smtClean="0">
                <a:latin typeface="Palatino Linotype" panose="02040502050505030304" pitchFamily="18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</a:rPr>
              <a:t>) Reactome pathway identifier mapping found 90 miR-124-3p validated target genes involved to different extents across a broad range of cellular pathways. (b) Over-representation of clinically relevant miR-124-3p targeted oncogenes in Reactome pathways. (c) Analysis of over-representation of clinically relevant miR-124-3p targeted tumour suppressor genes in Reactome pathways.</a:t>
            </a:r>
          </a:p>
        </p:txBody>
      </p:sp>
      <p:sp>
        <p:nvSpPr>
          <p:cNvPr id="17" name="Title 1"/>
          <p:cNvSpPr>
            <a:spLocks noGrp="1"/>
          </p:cNvSpPr>
          <p:nvPr>
            <p:ph type="title"/>
          </p:nvPr>
        </p:nvSpPr>
        <p:spPr>
          <a:xfrm>
            <a:off x="0" y="60311"/>
            <a:ext cx="6857999" cy="244489"/>
          </a:xfrm>
        </p:spPr>
        <p:txBody>
          <a:bodyPr>
            <a:noAutofit/>
          </a:bodyPr>
          <a:lstStyle/>
          <a:p>
            <a:r>
              <a:rPr lang="en-IE" sz="1800" dirty="0">
                <a:latin typeface="+mn-lt"/>
              </a:rPr>
              <a:t>Supplementary-</a:t>
            </a:r>
            <a:r>
              <a:rPr lang="en-IE" sz="1800" b="1" dirty="0">
                <a:latin typeface="+mn-lt"/>
              </a:rPr>
              <a:t> </a:t>
            </a:r>
            <a:r>
              <a:rPr lang="en-IE" sz="1800" dirty="0">
                <a:latin typeface="+mn-lt"/>
              </a:rPr>
              <a:t>S6</a:t>
            </a:r>
            <a:endParaRPr 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797497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199</TotalTime>
  <Words>529</Words>
  <Application>Microsoft Office PowerPoint</Application>
  <PresentationFormat>On-screen Show (4:3)</PresentationFormat>
  <Paragraphs>256</Paragraphs>
  <Slides>10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,Bold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Supplementary- S4</vt:lpstr>
      <vt:lpstr>Supplementary- S5</vt:lpstr>
      <vt:lpstr>PowerPoint Presentation</vt:lpstr>
      <vt:lpstr>PowerPoint Presentation</vt:lpstr>
      <vt:lpstr>Supplementary- S6</vt:lpstr>
      <vt:lpstr>PowerPoint Presentation</vt:lpstr>
    </vt:vector>
  </TitlesOfParts>
  <Company>Royal College of Surgeons in Ire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Nolan</dc:creator>
  <cp:lastModifiedBy>John Nolan</cp:lastModifiedBy>
  <cp:revision>162</cp:revision>
  <cp:lastPrinted>2020-07-22T14:09:42Z</cp:lastPrinted>
  <dcterms:created xsi:type="dcterms:W3CDTF">2018-12-10T17:20:44Z</dcterms:created>
  <dcterms:modified xsi:type="dcterms:W3CDTF">2020-11-10T13:57:03Z</dcterms:modified>
</cp:coreProperties>
</file>